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40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73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200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758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890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483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28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9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486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517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1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499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368B0-EBEB-47EC-AE17-E1EF82CA043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7D6F8-B049-435B-AA41-EBC548821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894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292785"/>
              </p:ext>
            </p:extLst>
          </p:nvPr>
        </p:nvGraphicFramePr>
        <p:xfrm>
          <a:off x="1702590" y="1291407"/>
          <a:ext cx="5850890" cy="3154426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1260475"/>
                <a:gridCol w="1800225"/>
                <a:gridCol w="1764030"/>
                <a:gridCol w="1026160"/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5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/>
                          <a:ea typeface="Times New Roman"/>
                        </a:rPr>
                        <a:t>haplotype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normoglycemic individuals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n (%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T2D patients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n (%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lang="en-US" sz="1100" i="1">
                          <a:effectLst/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value *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 dirty="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 dirty="0">
                          <a:effectLst/>
                          <a:latin typeface="Times New Roman"/>
                          <a:ea typeface="Times New Roman"/>
                        </a:rPr>
                        <a:t>TCCG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362 (36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213 (35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0.95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ACCG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287 (29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152 (25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0.24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TCTG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166 (17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122 (20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0.14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TCTA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104 (10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71 (12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0.43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TTCG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80 (8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effectLst/>
                          <a:latin typeface="Times New Roman"/>
                          <a:ea typeface="Times New Roman"/>
                        </a:rPr>
                        <a:t>42 (7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 dirty="0">
                          <a:effectLst/>
                          <a:latin typeface="Times New Roman"/>
                          <a:ea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500"/>
                        </a:spcAft>
                      </a:pPr>
                      <a:r>
                        <a:rPr lang="en-US" sz="1100" dirty="0">
                          <a:effectLst/>
                          <a:latin typeface="Times New Roman"/>
                          <a:ea typeface="Times New Roman"/>
                        </a:rPr>
                        <a:t>0.54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287775" y="909881"/>
            <a:ext cx="468052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Table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Distribution of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GJD2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haplotypes in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Laus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cohor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</p:txBody>
      </p:sp>
      <p:sp>
        <p:nvSpPr>
          <p:cNvPr id="6" name="Rectangle 5"/>
          <p:cNvSpPr/>
          <p:nvPr/>
        </p:nvSpPr>
        <p:spPr>
          <a:xfrm>
            <a:off x="1711711" y="4819799"/>
            <a:ext cx="5832648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ontrol and case distributions were compared by a Pearson chi square test. A = adenine; C =cytosine; G = guanine; T = thymine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3921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2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5</cp:revision>
  <dcterms:created xsi:type="dcterms:W3CDTF">2015-03-29T16:42:37Z</dcterms:created>
  <dcterms:modified xsi:type="dcterms:W3CDTF">2015-11-15T16:31:38Z</dcterms:modified>
</cp:coreProperties>
</file>